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840" y="1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63F2AD-D21D-4D2E-B795-64BEB83A54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B14214-65A2-4585-8876-1EF44D6FE4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896A96-A17B-434F-83A6-30CAD8FBC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B3375E-1CE3-44AF-9161-75F69E205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D2475A-F946-44C5-A667-9613AF85AB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8035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AAB47E-6E7B-4682-A34A-3FB98EDD13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355EE1-8953-4E90-8D33-F05DC9D68D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53D128-0348-4BDD-B377-68430C509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8A6B40-5690-4D17-9490-CC7A2FFEE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402A76-34F8-4E5D-BA17-B515BBA76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9110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E6F7137-CC33-472D-BA30-7A5C7407C7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BFB3B0-599E-4B3C-9D31-B0418008DB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AF27D8-8761-40E3-9BF8-655AF23B0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0AE5F4-2234-4103-90B9-07054835CB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44E127-2EC0-4A1A-AABD-A5AEA5D93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83899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A0EFB0-3CEE-4871-8E80-8723B66824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521011-F388-44B0-8BC8-28909C42EB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FBC00C-B8BF-418A-8DCC-08CF691A6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2A99DF-C1C8-40B9-83F0-3DEAB9B5F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321A79-85C9-4BAE-83E0-7C194662A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4520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210328-CAC3-4EED-9667-24BF26D955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A6A1F1-5400-4364-AFF3-E398C76108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C441AB-ACC0-4876-B6D2-1C25B1B49B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851DCE-FA5D-4311-B088-D754496D7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3BF88B-20EA-4128-A7FE-9E46EE83E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15580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90FAF6-6425-4CBB-A620-E2E8C9D451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CB2320-92DB-4375-99C6-3DF904FC05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642594-CC0E-4777-9404-8DD5D0C7A7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EE851F-31C6-45D5-9013-61B6EDF8FC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159B11-36EA-4470-9734-F47797881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09BEED-2FB3-4FDF-A847-58D2EEF55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62671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194416-1142-4F95-8C99-5E97629FF6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FCFD70-D84E-4EE3-812D-E815610B99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75DD8E-0108-492D-B825-94C551CC72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DDD8196-4685-4158-9776-02D00F9BC6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E653CD5-6244-465B-A33A-6FE687DFB5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B0B70D3-A63B-4902-9701-5197ED9EE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F11415-48E4-491C-A3B4-11978FAE1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CB0501-C808-4215-A91C-0EC904EB5B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6298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C8AE9-28E2-4414-9E28-19D7B5CE70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DA1141-52C7-4EAD-935B-553118A95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F57C24B-BA67-4DB9-9B37-FA8AC51F1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8704FB-22A2-44B6-86C7-6A6AD9C74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3986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A0CC8B-7E2D-458C-A481-C723C6772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243C0C-E579-4E0A-8A52-39A4C92866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211157-467A-4365-AE9C-3AF850030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65132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79ECB2-3AEF-466D-8D65-D1B32212EA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E00D98-7D82-459B-A060-74DB9632A1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4685A4-025D-4F68-A7A0-F2BBE2B19E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160748-FFA3-4AD9-A7D2-D200778F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6DCA69-B597-4349-AE30-B7B886C32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62A1AB-C2BE-4153-88F5-EF3920F0C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25178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033601-439B-4329-8235-573F64F2A0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D5C3A6F-57CB-43E3-BF07-DDB518E65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7BD10B-9177-4378-BB0B-200BC8A227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47FD44-C7D5-4A10-8A19-3ADE95932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AE7226-812D-4040-AC6A-F721BE2000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F1FD55-75E3-4CF5-AB25-F08DD7557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39165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DCEA07-72B8-4D1E-B489-3163BACBBB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84EA6D-DEC3-4BB3-BEF3-EEC37ACA18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AF0A19-77FA-4B4A-BD22-8CE623D7F3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C9A7DE-6148-43F0-BEC9-C4F950101AFE}" type="datetimeFigureOut">
              <a:rPr lang="en-IN" smtClean="0"/>
              <a:t>13-04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3BEF5A-7D09-4308-B25B-FD249DB643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3BB5D2-DADF-4ABC-BB5E-08806941F5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C07152-0CFC-40E3-A64A-D0D074582EE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3409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6E88136-292A-46AA-B18E-02306FE8DE57}"/>
              </a:ext>
            </a:extLst>
          </p:cNvPr>
          <p:cNvSpPr txBox="1"/>
          <p:nvPr/>
        </p:nvSpPr>
        <p:spPr>
          <a:xfrm>
            <a:off x="1359693" y="5396863"/>
            <a:ext cx="9472613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ea typeface="Times New Roman" panose="02020603050405020304" pitchFamily="18" charset="0"/>
              </a:rPr>
              <a:t>Supplementary Figure 6A: </a:t>
            </a:r>
            <a:r>
              <a:rPr lang="en-US" sz="1400" dirty="0">
                <a:ea typeface="Times New Roman" panose="02020603050405020304" pitchFamily="18" charset="0"/>
              </a:rPr>
              <a:t>Restriction digestion of </a:t>
            </a:r>
            <a:r>
              <a:rPr lang="en-US" sz="1400" dirty="0" err="1">
                <a:ea typeface="Times New Roman" panose="02020603050405020304" pitchFamily="18" charset="0"/>
              </a:rPr>
              <a:t>pGEMT</a:t>
            </a:r>
            <a:r>
              <a:rPr lang="en-US" sz="1400" dirty="0">
                <a:ea typeface="Times New Roman" panose="02020603050405020304" pitchFamily="18" charset="0"/>
              </a:rPr>
              <a:t>-Easy vector cloned pre-NmiR1 PCR product.</a:t>
            </a:r>
            <a:r>
              <a:rPr lang="en-US" sz="1400" b="1" dirty="0">
                <a:ea typeface="Times New Roman" panose="02020603050405020304" pitchFamily="18" charset="0"/>
              </a:rPr>
              <a:t> </a:t>
            </a:r>
            <a:r>
              <a:rPr lang="en-US" sz="1400" dirty="0">
                <a:ea typeface="Times New Roman" panose="02020603050405020304" pitchFamily="18" charset="0"/>
              </a:rPr>
              <a:t>The clone was digested with both the </a:t>
            </a:r>
            <a:r>
              <a:rPr lang="en-US" sz="1400" i="1" dirty="0" err="1">
                <a:ea typeface="Times New Roman" panose="02020603050405020304" pitchFamily="18" charset="0"/>
              </a:rPr>
              <a:t>EcoR</a:t>
            </a:r>
            <a:r>
              <a:rPr lang="en-US" sz="1400" dirty="0" err="1">
                <a:ea typeface="Times New Roman" panose="02020603050405020304" pitchFamily="18" charset="0"/>
              </a:rPr>
              <a:t>I</a:t>
            </a:r>
            <a:r>
              <a:rPr lang="en-US" sz="1400" dirty="0">
                <a:ea typeface="Times New Roman" panose="02020603050405020304" pitchFamily="18" charset="0"/>
              </a:rPr>
              <a:t> and</a:t>
            </a:r>
            <a:r>
              <a:rPr lang="en-US" sz="1400" i="1" dirty="0">
                <a:ea typeface="Times New Roman" panose="02020603050405020304" pitchFamily="18" charset="0"/>
              </a:rPr>
              <a:t> </a:t>
            </a:r>
            <a:r>
              <a:rPr lang="en-US" sz="1400" i="1" dirty="0" err="1">
                <a:ea typeface="Times New Roman" panose="02020603050405020304" pitchFamily="18" charset="0"/>
              </a:rPr>
              <a:t>SsP</a:t>
            </a:r>
            <a:r>
              <a:rPr lang="en-US" sz="1400" dirty="0" err="1">
                <a:ea typeface="Times New Roman" panose="02020603050405020304" pitchFamily="18" charset="0"/>
              </a:rPr>
              <a:t>I</a:t>
            </a:r>
            <a:r>
              <a:rPr lang="en-US" sz="1400" dirty="0">
                <a:ea typeface="Times New Roman" panose="02020603050405020304" pitchFamily="18" charset="0"/>
              </a:rPr>
              <a:t>. The expected product size of 115 bp and 2992 bp were observed (Digested) when compared with undigested product (Undigested) of </a:t>
            </a:r>
            <a:r>
              <a:rPr lang="en-US" sz="1400" i="1" dirty="0" err="1">
                <a:ea typeface="Times New Roman" panose="02020603050405020304" pitchFamily="18" charset="0"/>
              </a:rPr>
              <a:t>EcoR</a:t>
            </a:r>
            <a:r>
              <a:rPr lang="en-US" sz="1400" dirty="0" err="1">
                <a:ea typeface="Times New Roman" panose="02020603050405020304" pitchFamily="18" charset="0"/>
              </a:rPr>
              <a:t>I</a:t>
            </a:r>
            <a:r>
              <a:rPr lang="en-US" sz="1400" dirty="0">
                <a:ea typeface="Times New Roman" panose="02020603050405020304" pitchFamily="18" charset="0"/>
              </a:rPr>
              <a:t>. For </a:t>
            </a:r>
            <a:r>
              <a:rPr lang="en-US" sz="1400" i="1" dirty="0" err="1">
                <a:ea typeface="Times New Roman" panose="02020603050405020304" pitchFamily="18" charset="0"/>
              </a:rPr>
              <a:t>SsP</a:t>
            </a:r>
            <a:r>
              <a:rPr lang="en-US" sz="1400" dirty="0" err="1">
                <a:ea typeface="Times New Roman" panose="02020603050405020304" pitchFamily="18" charset="0"/>
              </a:rPr>
              <a:t>I</a:t>
            </a:r>
            <a:r>
              <a:rPr lang="en-US" sz="1400" dirty="0">
                <a:ea typeface="Times New Roman" panose="02020603050405020304" pitchFamily="18" charset="0"/>
              </a:rPr>
              <a:t> digestion, the expected product size of 182 bp, 848 bp and 2095 bp were observed (Digested) when compared with undigested product (Undigested). 1 kb plus ladder (</a:t>
            </a:r>
            <a:r>
              <a:rPr lang="en-US" sz="1400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7</a:t>
            </a:r>
            <a:r>
              <a:rPr lang="en-US" sz="1400" dirty="0">
                <a:ea typeface="Times New Roman" panose="02020603050405020304" pitchFamily="18" charset="0"/>
              </a:rPr>
              <a:t>5-20,000 bp) (Gene ruler, Thermo scientific) was used as reference marker.</a:t>
            </a:r>
            <a:endParaRPr lang="en-US" sz="14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23D0BF5-9DF9-4D6F-B55E-00B71CE739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50782" y="297104"/>
            <a:ext cx="3695700" cy="42291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686280F-A27D-4CCE-B255-01B5DE955073}"/>
              </a:ext>
            </a:extLst>
          </p:cNvPr>
          <p:cNvSpPr txBox="1"/>
          <p:nvPr/>
        </p:nvSpPr>
        <p:spPr>
          <a:xfrm rot="18405303">
            <a:off x="5781083" y="497787"/>
            <a:ext cx="2120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1DA6FDD-82FE-47B9-B957-41C5CD654406}"/>
              </a:ext>
            </a:extLst>
          </p:cNvPr>
          <p:cNvSpPr txBox="1"/>
          <p:nvPr/>
        </p:nvSpPr>
        <p:spPr>
          <a:xfrm rot="18405303">
            <a:off x="4297000" y="497786"/>
            <a:ext cx="2120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</a:p>
        </p:txBody>
      </p:sp>
    </p:spTree>
    <p:extLst>
      <p:ext uri="{BB962C8B-B14F-4D97-AF65-F5344CB8AC3E}">
        <p14:creationId xmlns:p14="http://schemas.microsoft.com/office/powerpoint/2010/main" val="32715464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A27C353-1CCA-4498-853E-49A3189CAB90}"/>
              </a:ext>
            </a:extLst>
          </p:cNvPr>
          <p:cNvSpPr txBox="1"/>
          <p:nvPr/>
        </p:nvSpPr>
        <p:spPr>
          <a:xfrm>
            <a:off x="466060" y="909889"/>
            <a:ext cx="11259879" cy="38892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Pre-NmiR1 </a:t>
            </a:r>
            <a:r>
              <a:rPr lang="en-US" sz="16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pGEMT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-Easy clone sequencing data:</a:t>
            </a:r>
            <a:endParaRPr lang="en-IN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  <a:p>
            <a:pPr marR="0" lvl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1) Pre-NmiR1 sequence:</a:t>
            </a:r>
            <a:endParaRPr lang="en-IN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dirty="0">
                <a:effectLst/>
                <a:highlight>
                  <a:srgbClr val="00FFFF"/>
                </a:highlight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CCTTTGGCCTCCATTGATTC</a:t>
            </a:r>
            <a:r>
              <a:rPr lang="en-US" sz="16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ATCAATAAATAATGTTACATGTAATATTCTCCGTGTGTTATATGGTGGCTATAGTTTAGTGGTAGAATT</a:t>
            </a:r>
            <a:r>
              <a:rPr lang="en-US" sz="1600" dirty="0">
                <a:effectLst/>
                <a:highlight>
                  <a:srgbClr val="00FF00"/>
                </a:highlight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CTTACCAGCCACAAATTAACG</a:t>
            </a:r>
            <a:endParaRPr lang="en-IN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dirty="0">
                <a:effectLst/>
                <a:highlight>
                  <a:srgbClr val="00FFFF"/>
                </a:highlight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Sky blue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 represents forward primer region; </a:t>
            </a:r>
            <a:r>
              <a:rPr lang="en-US" sz="1600" dirty="0">
                <a:effectLst/>
                <a:highlight>
                  <a:srgbClr val="00FF00"/>
                </a:highlight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Green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 for reverse primer region</a:t>
            </a:r>
            <a:endParaRPr lang="en-IN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 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2) Sanger sequencing result of </a:t>
            </a:r>
            <a:r>
              <a:rPr lang="en-US" sz="16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pGEMT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-Easy – pre-NmiR1 clone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:</a:t>
            </a:r>
            <a:endParaRPr lang="en-IN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dirty="0">
                <a:effectLst/>
                <a:highlight>
                  <a:srgbClr val="808080"/>
                </a:highlight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GTAAAACGACGGCCAGTGAATTGTAATACGACTCACTATAGGGCGAATTGGGCCCGACGTCGCATGCTCCCGGCCGCCATGGCGGCCGCGGGAATTCGATT</a:t>
            </a:r>
            <a:r>
              <a:rPr lang="en-US" sz="16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CGTTAATTTGTGGCTGGTAAGAATTCTACCACTAAACTATAGCCACCATATAACACACGGAGAATATTACATGTAACATTATTTATTGATGAATCAATGGAGGCCAAAGG</a:t>
            </a:r>
            <a:r>
              <a:rPr lang="en-US" sz="1600" dirty="0">
                <a:effectLst/>
                <a:highlight>
                  <a:srgbClr val="808080"/>
                </a:highlight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ATCACTAGTGAATTCGCGGCCGCCTGCAGGTCGACCATATGGGAGAGCTCCCAACGCGTTGGATGCATAGCTTGAGTATTCTATAGTGTCACCTAAATAGCTTGGCGTAATCATGGTCATAGCTGTTTCCTGTGTGAAATTGTTATCCGCTCACAATTCCACACAACATACGAGCCGGAAGCATAAAGTGTAAAGCCTGGGGTGCCTAATGAGTGAGCTAACTCACATTAATTGCGTTGCGCTCACTGCCCGCTTTCCA</a:t>
            </a:r>
            <a:endParaRPr lang="en-IN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 </a:t>
            </a:r>
            <a:r>
              <a:rPr lang="en-US" sz="1600" dirty="0">
                <a:effectLst/>
                <a:highlight>
                  <a:srgbClr val="808080"/>
                </a:highlight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Grey background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Latha" panose="020B0604020202020204" pitchFamily="34" charset="0"/>
              </a:rPr>
              <a:t> represents the vector backbone sequence.</a:t>
            </a:r>
            <a:endParaRPr lang="en-IN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1986D20-EAEB-476D-A13C-8A5F5148B019}"/>
              </a:ext>
            </a:extLst>
          </p:cNvPr>
          <p:cNvSpPr txBox="1"/>
          <p:nvPr/>
        </p:nvSpPr>
        <p:spPr>
          <a:xfrm>
            <a:off x="636679" y="5311803"/>
            <a:ext cx="1078268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ea typeface="Times New Roman" panose="02020603050405020304" pitchFamily="18" charset="0"/>
              </a:rPr>
              <a:t>Supplementary </a:t>
            </a:r>
            <a:r>
              <a:rPr lang="en-US" sz="1400" b="1">
                <a:ea typeface="Times New Roman" panose="02020603050405020304" pitchFamily="18" charset="0"/>
              </a:rPr>
              <a:t>Figure 6B: </a:t>
            </a:r>
            <a:r>
              <a:rPr lang="en-US" sz="1400" dirty="0">
                <a:ea typeface="Times New Roman" panose="02020603050405020304" pitchFamily="18" charset="0"/>
              </a:rPr>
              <a:t>Sequencing data of the pre-NmiR1 cloned </a:t>
            </a:r>
            <a:r>
              <a:rPr lang="en-US" sz="1400" dirty="0" err="1">
                <a:ea typeface="Times New Roman" panose="02020603050405020304" pitchFamily="18" charset="0"/>
              </a:rPr>
              <a:t>pGEMT</a:t>
            </a:r>
            <a:r>
              <a:rPr lang="en-US" sz="1400" dirty="0">
                <a:ea typeface="Times New Roman" panose="02020603050405020304" pitchFamily="18" charset="0"/>
              </a:rPr>
              <a:t>-Easy vector. The yellow background sequence is the expected pre-NmiR1 sequence and the vector backbone sequence was highlighted with grey background. 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254922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0</TotalTime>
  <Words>183</Words>
  <Application>Microsoft Office PowerPoint</Application>
  <PresentationFormat>Widescreen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gesh S</dc:creator>
  <cp:lastModifiedBy>Nagesh S</cp:lastModifiedBy>
  <cp:revision>10</cp:revision>
  <dcterms:created xsi:type="dcterms:W3CDTF">2022-04-11T18:12:20Z</dcterms:created>
  <dcterms:modified xsi:type="dcterms:W3CDTF">2022-04-13T04:29:15Z</dcterms:modified>
</cp:coreProperties>
</file>